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29A9A-249E-4941-8737-497A5A2600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F5036-241D-465D-91CD-4F77D7C91D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212DEF-5CBC-426A-9B9C-2FC72E4810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5E438-09F7-4FB9-9EF9-C7E7CFEC6D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52AF5-FBCE-4455-8089-5FC1024910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B169B-340B-47A2-9444-D9101E47E3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CE3FF-8F64-4F5E-A558-B85F7AB885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A0650-B725-41BB-8DC6-469191CB44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8B6A0-3BC1-4337-92A6-9CA4C052D4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33A5A-415D-431D-8A98-D58E11210F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32108-8C04-4878-8F34-8F66AA5893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0D3A7-C62C-421D-917E-E24B2F87A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136C91-F39C-4C48-BF90-4FA29E2A31D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Pure biogenic nucleation rates versus HOM concentr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D:\PPT_Out\nature-logo.jpg"/>
          <p:cNvPicPr/>
          <p:nvPr/>
        </p:nvPicPr>
        <p:blipFill>
          <a:blip r:embed="rId1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3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J Kirkby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 et al.  Nature 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533,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521–526 (2016) doi:10.1038/nature179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6" descr="D:\Shilpa\2016\May\18\nature17953\300 dpi\nature17953-f3.jpg"/>
          <p:cNvPicPr/>
          <p:nvPr/>
        </p:nvPicPr>
        <p:blipFill>
          <a:blip r:embed="rId2"/>
          <a:stretch/>
        </p:blipFill>
        <p:spPr>
          <a:xfrm>
            <a:off x="2286000" y="1676520"/>
            <a:ext cx="4572000" cy="374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4T11:33:05Z</dcterms:created>
  <dc:creator>ravikumar.n</dc:creator>
  <dc:description/>
  <dc:language>en-US</dc:language>
  <cp:lastModifiedBy>Ky.Shilpashree</cp:lastModifiedBy>
  <dcterms:modified xsi:type="dcterms:W3CDTF">2016-05-18T09:51:55Z</dcterms:modified>
  <cp:revision>12</cp:revision>
  <dc:subject/>
  <dc:title>Phylogenetic relationship of salmonids and relevant teleost lineages</dc:title>
</cp:coreProperties>
</file>